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78" d="100"/>
          <a:sy n="78" d="100"/>
        </p:scale>
        <p:origin x="739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12847F-861A-4023-8E63-42378AFCBB08}" type="datetimeFigureOut">
              <a:rPr lang="nl-NL" smtClean="0"/>
              <a:t>2-9-2021</a:t>
            </a:fld>
            <a:endParaRPr lang="nl-N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DF8A9D-E339-4BBC-9198-64C7FE3A546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894052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Ik</a:t>
            </a:r>
            <a:r>
              <a:rPr lang="en-US" dirty="0"/>
              <a:t> </a:t>
            </a:r>
            <a:r>
              <a:rPr lang="en-US" dirty="0" err="1"/>
              <a:t>weet</a:t>
            </a:r>
            <a:r>
              <a:rPr lang="en-US" dirty="0"/>
              <a:t> </a:t>
            </a:r>
            <a:r>
              <a:rPr lang="en-US" dirty="0" err="1"/>
              <a:t>niet</a:t>
            </a:r>
            <a:r>
              <a:rPr lang="en-US" dirty="0"/>
              <a:t> </a:t>
            </a:r>
            <a:r>
              <a:rPr lang="en-US" dirty="0" err="1"/>
              <a:t>precies</a:t>
            </a:r>
            <a:r>
              <a:rPr lang="en-US" dirty="0"/>
              <a:t> </a:t>
            </a:r>
            <a:r>
              <a:rPr lang="en-US" dirty="0" err="1"/>
              <a:t>hoeveel</a:t>
            </a:r>
            <a:r>
              <a:rPr lang="en-US" baseline="0" dirty="0"/>
              <a:t> ED visits </a:t>
            </a:r>
            <a:r>
              <a:rPr lang="en-US" baseline="0" dirty="0" err="1"/>
              <a:t>er</a:t>
            </a:r>
            <a:r>
              <a:rPr lang="en-US" baseline="0" dirty="0"/>
              <a:t> </a:t>
            </a:r>
            <a:r>
              <a:rPr lang="en-US" baseline="0" dirty="0" err="1"/>
              <a:t>zijn</a:t>
            </a:r>
            <a:r>
              <a:rPr lang="en-US" baseline="0" dirty="0"/>
              <a:t> </a:t>
            </a:r>
            <a:r>
              <a:rPr lang="en-US" baseline="0" dirty="0" err="1"/>
              <a:t>geweest</a:t>
            </a:r>
            <a:r>
              <a:rPr lang="en-US" baseline="0" dirty="0"/>
              <a:t>, </a:t>
            </a:r>
            <a:r>
              <a:rPr lang="en-US" baseline="0" dirty="0" err="1"/>
              <a:t>dus</a:t>
            </a:r>
            <a:r>
              <a:rPr lang="en-US" baseline="0" dirty="0"/>
              <a:t> </a:t>
            </a:r>
            <a:r>
              <a:rPr lang="en-US" baseline="0" dirty="0" err="1"/>
              <a:t>daarom</a:t>
            </a:r>
            <a:r>
              <a:rPr lang="en-US" baseline="0" dirty="0"/>
              <a:t> </a:t>
            </a:r>
            <a:r>
              <a:rPr lang="en-US" baseline="0" dirty="0" err="1"/>
              <a:t>staat</a:t>
            </a:r>
            <a:r>
              <a:rPr lang="en-US" baseline="0" dirty="0"/>
              <a:t> </a:t>
            </a:r>
            <a:r>
              <a:rPr lang="en-US" baseline="0" dirty="0" err="1"/>
              <a:t>dit</a:t>
            </a:r>
            <a:r>
              <a:rPr lang="en-US" baseline="0" dirty="0"/>
              <a:t> </a:t>
            </a:r>
            <a:r>
              <a:rPr lang="en-US" baseline="0" dirty="0" err="1"/>
              <a:t>getal</a:t>
            </a:r>
            <a:r>
              <a:rPr lang="en-US" baseline="0" dirty="0"/>
              <a:t> nog in rood.</a:t>
            </a:r>
          </a:p>
          <a:p>
            <a:endParaRPr lang="en-US" baseline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C670CB-A757-4988-960B-0D102D6CC39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51613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E4FE0B-4A51-42A0-9CF3-F956DE01A1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59C1405-E89E-4D92-988B-F4E65E7AD0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FA1ACB-75E3-4A1A-8B3B-DF15674AFA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EE0C4D-E2B6-4512-A221-8DD32B0D699B}" type="datetimeFigureOut">
              <a:rPr lang="nl-NL" smtClean="0"/>
              <a:t>2-9-2021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0B0627-7B05-44DF-962E-AE9CCDF7C9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CA9315-BE35-4D90-8058-CD55249E50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428C6-8733-4A1A-A999-EE829F7582E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043198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43064F-4AD1-454B-97B0-7CB1DA5EDE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C64866-454D-418A-87A0-9B24E4A209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5BDB8C-C1E1-43A8-99D0-C37A98BA1B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EE0C4D-E2B6-4512-A221-8DD32B0D699B}" type="datetimeFigureOut">
              <a:rPr lang="nl-NL" smtClean="0"/>
              <a:t>2-9-2021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39AD3D-F909-4969-B275-43C2810550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158978-5044-47F3-9189-AA4D246D8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428C6-8733-4A1A-A999-EE829F7582E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07750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966A1D8-804C-46A3-880A-8C24F96061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AD89B9-E0C9-44B3-B4E2-ABE3495128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3023A9-AA3E-4F62-B63D-CEA5765353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EE0C4D-E2B6-4512-A221-8DD32B0D699B}" type="datetimeFigureOut">
              <a:rPr lang="nl-NL" smtClean="0"/>
              <a:t>2-9-2021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E8DFD7-CBD8-4DB6-9FCC-8EC96FEE5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9F7C52-3FB7-413F-8A63-F03C868CDB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428C6-8733-4A1A-A999-EE829F7582E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79457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BB27D4-2419-4D62-BD74-DE90D1E47F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2454FF-ACFC-4733-9301-CFE60D4246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261B0D-4E68-442C-950C-931290655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EE0C4D-E2B6-4512-A221-8DD32B0D699B}" type="datetimeFigureOut">
              <a:rPr lang="nl-NL" smtClean="0"/>
              <a:t>2-9-2021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A86CCE-83EC-4FBA-99C4-1C1D821BA6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2F20DC-743D-4C09-8FFA-DE30834945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428C6-8733-4A1A-A999-EE829F7582E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044369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BD69C1-611A-4ACB-B2DE-852B753264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080D6C-E042-4850-821F-56C9C5EED2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DD367D-2007-4C1E-8C10-46C63E3F2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EE0C4D-E2B6-4512-A221-8DD32B0D699B}" type="datetimeFigureOut">
              <a:rPr lang="nl-NL" smtClean="0"/>
              <a:t>2-9-2021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6A3D8A-33CD-4472-8EE0-23DC29176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D0E955-1CFE-4381-911C-383D91C9DF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428C6-8733-4A1A-A999-EE829F7582E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99093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01C526-4803-4A5D-81A1-9ECCC5FF2E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87B04E-270D-49CA-9E4D-0942D44370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2997CC-1385-4ACA-89D8-24C096F29A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8E8B32-926F-4A2D-93FB-DE3F5384E7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EE0C4D-E2B6-4512-A221-8DD32B0D699B}" type="datetimeFigureOut">
              <a:rPr lang="nl-NL" smtClean="0"/>
              <a:t>2-9-2021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DB8F08-B451-4BA7-8934-F0BEA6219A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3EC4FB-CC66-46BB-9E9C-858AA24481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428C6-8733-4A1A-A999-EE829F7582E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778019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AD0763-C8DA-4D6C-AAF1-4A18B63280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7DEFF8-8405-4DB9-8747-00F0E3C4E9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94FCF9-485E-4939-B108-75A2EB2C2E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9CBE996-F868-406A-B132-FE47214567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9584A0F-64CA-467E-A150-B24949FB208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43B9BA-E5C4-47AE-90D2-615FF6169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EE0C4D-E2B6-4512-A221-8DD32B0D699B}" type="datetimeFigureOut">
              <a:rPr lang="nl-NL" smtClean="0"/>
              <a:t>2-9-2021</a:t>
            </a:fld>
            <a:endParaRPr lang="nl-N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CCA697B-ED5E-49C7-9E8E-2C77AA2F44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0EA46F-0FF1-41BB-9A8F-7F84394B15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428C6-8733-4A1A-A999-EE829F7582E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57690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D32D34-C1B8-4FD2-B696-E7E56778A1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F2A76FB-E9B6-4300-A640-4CBCAC7B89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EE0C4D-E2B6-4512-A221-8DD32B0D699B}" type="datetimeFigureOut">
              <a:rPr lang="nl-NL" smtClean="0"/>
              <a:t>2-9-2021</a:t>
            </a:fld>
            <a:endParaRPr lang="nl-N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9958E14-13D1-4BEB-9AFD-7F98CD4458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F579E5C-DC8B-4091-9C1A-E55641C09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428C6-8733-4A1A-A999-EE829F7582E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883147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9A8F7F6-6607-44B3-8AC4-3466F6370D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EE0C4D-E2B6-4512-A221-8DD32B0D699B}" type="datetimeFigureOut">
              <a:rPr lang="nl-NL" smtClean="0"/>
              <a:t>2-9-2021</a:t>
            </a:fld>
            <a:endParaRPr lang="nl-N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49F7416-18B6-4DC5-99B7-76385F653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A793A9F-02BD-4D8C-BD92-1ABC3A452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428C6-8733-4A1A-A999-EE829F7582E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750887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F8F38A-73FA-4C85-BA46-CE299DDC6F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7C3934-770E-4966-88CE-F9325D5822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76DF3F-28A3-4839-97F9-7C5B34C85B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058AFF-5865-4454-AB12-002DA1AAFF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EE0C4D-E2B6-4512-A221-8DD32B0D699B}" type="datetimeFigureOut">
              <a:rPr lang="nl-NL" smtClean="0"/>
              <a:t>2-9-2021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EE4922-A76B-46A7-B718-F1C8885F8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285602-AE55-4B13-802B-0B5C459143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428C6-8733-4A1A-A999-EE829F7582E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85896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2B8641-57EC-4DAE-A702-580662C67B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72912F0-6678-4291-A97B-3431087B2B5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EC18A7F-4F3B-49C5-A49E-262CD7DFD0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1F3179-ADFC-4668-A1F9-06F175D4D9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EE0C4D-E2B6-4512-A221-8DD32B0D699B}" type="datetimeFigureOut">
              <a:rPr lang="nl-NL" smtClean="0"/>
              <a:t>2-9-2021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D4393B-39A4-43C6-A747-15D594C50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2ECFED-2984-400C-8BBD-0996FA73D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428C6-8733-4A1A-A999-EE829F7582E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42890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B28F14B-02C9-4AF1-B311-2CCD6C1B40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BA0D39-4B5A-4997-9469-5FE5A32F28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476747-1505-492B-95F0-2A2161610F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EE0C4D-E2B6-4512-A221-8DD32B0D699B}" type="datetimeFigureOut">
              <a:rPr lang="nl-NL" smtClean="0"/>
              <a:t>2-9-2021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800EAC-7EFC-4789-A7C7-82EECFC1A8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AB906A-B820-467D-9FB8-22F265D8FE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E428C6-8733-4A1A-A999-EE829F7582E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37810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794C26B3-C01C-4D59-8BFD-1BD3225F96E5}"/>
              </a:ext>
            </a:extLst>
          </p:cNvPr>
          <p:cNvGrpSpPr/>
          <p:nvPr/>
        </p:nvGrpSpPr>
        <p:grpSpPr>
          <a:xfrm>
            <a:off x="3312422" y="1071612"/>
            <a:ext cx="6895381" cy="4162164"/>
            <a:chOff x="3312422" y="1071612"/>
            <a:chExt cx="6895381" cy="4162164"/>
          </a:xfrm>
        </p:grpSpPr>
        <p:grpSp>
          <p:nvGrpSpPr>
            <p:cNvPr id="17" name="Group 16"/>
            <p:cNvGrpSpPr/>
            <p:nvPr/>
          </p:nvGrpSpPr>
          <p:grpSpPr>
            <a:xfrm>
              <a:off x="5169742" y="1432859"/>
              <a:ext cx="1852516" cy="600164"/>
              <a:chOff x="3739174" y="260648"/>
              <a:chExt cx="1607007" cy="600164"/>
            </a:xfrm>
          </p:grpSpPr>
          <p:sp>
            <p:nvSpPr>
              <p:cNvPr id="2" name="Rectangle 1"/>
              <p:cNvSpPr/>
              <p:nvPr/>
            </p:nvSpPr>
            <p:spPr>
              <a:xfrm>
                <a:off x="3743037" y="260648"/>
                <a:ext cx="1603144" cy="57606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3739174" y="260648"/>
                <a:ext cx="1607007" cy="6001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72,104 ED visits in three</a:t>
                </a:r>
              </a:p>
              <a:p>
                <a:pPr algn="ctr"/>
                <a:r>
                  <a:rPr lang="en-GB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hospitals during study period</a:t>
                </a:r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4655980" y="3503105"/>
              <a:ext cx="2857014" cy="504626"/>
              <a:chOff x="3319022" y="1112451"/>
              <a:chExt cx="2471088" cy="646331"/>
            </a:xfrm>
          </p:grpSpPr>
          <p:sp>
            <p:nvSpPr>
              <p:cNvPr id="3" name="Rectangle 2"/>
              <p:cNvSpPr/>
              <p:nvPr/>
            </p:nvSpPr>
            <p:spPr>
              <a:xfrm>
                <a:off x="3319022" y="1112451"/>
                <a:ext cx="2451173" cy="64633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3319022" y="1137376"/>
                <a:ext cx="2471088" cy="551885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GB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94,974 ED visits with measured</a:t>
                </a:r>
              </a:p>
              <a:p>
                <a:pPr algn="ctr"/>
                <a:r>
                  <a:rPr lang="en-GB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biomarkers</a:t>
                </a:r>
              </a:p>
            </p:txBody>
          </p:sp>
          <p:cxnSp>
            <p:nvCxnSpPr>
              <p:cNvPr id="53" name="Straight Arrow Connector 52"/>
              <p:cNvCxnSpPr>
                <a:stCxn id="3" idx="2"/>
                <a:endCxn id="3" idx="2"/>
              </p:cNvCxnSpPr>
              <p:nvPr/>
            </p:nvCxnSpPr>
            <p:spPr>
              <a:xfrm>
                <a:off x="4544609" y="1758782"/>
                <a:ext cx="0" cy="0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3" name="Straight Arrow Connector 92"/>
            <p:cNvCxnSpPr>
              <a:cxnSpLocks/>
              <a:stCxn id="3" idx="2"/>
            </p:cNvCxnSpPr>
            <p:nvPr/>
          </p:nvCxnSpPr>
          <p:spPr>
            <a:xfrm flipH="1">
              <a:off x="4402011" y="4007731"/>
              <a:ext cx="1670964" cy="78287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3586546" y="1071612"/>
              <a:ext cx="28570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l digital </a:t>
              </a:r>
              <a:r>
                <a:rPr lang="en-GB" sz="1400" b="1">
                  <a:latin typeface="Arial" panose="020B0604020202020204" pitchFamily="34" charset="0"/>
                  <a:cs typeface="Arial" panose="020B0604020202020204" pitchFamily="34" charset="0"/>
                </a:rPr>
                <a:t>content 3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1" name="Straight Arrow Connector 80"/>
            <p:cNvCxnSpPr>
              <a:cxnSpLocks/>
              <a:stCxn id="3" idx="2"/>
            </p:cNvCxnSpPr>
            <p:nvPr/>
          </p:nvCxnSpPr>
          <p:spPr>
            <a:xfrm>
              <a:off x="6072975" y="4007731"/>
              <a:ext cx="1713592" cy="77696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Box 83"/>
            <p:cNvSpPr txBox="1"/>
            <p:nvPr/>
          </p:nvSpPr>
          <p:spPr>
            <a:xfrm>
              <a:off x="3312422" y="4802889"/>
              <a:ext cx="1343558" cy="43088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18-50 years</a:t>
              </a:r>
            </a:p>
            <a:p>
              <a:pPr algn="ctr"/>
              <a:r>
                <a:rPr lang="en-GB" sz="1100">
                  <a:latin typeface="Arial" panose="020B0604020202020204" pitchFamily="34" charset="0"/>
                  <a:cs typeface="Arial" panose="020B0604020202020204" pitchFamily="34" charset="0"/>
                </a:rPr>
                <a:t>26,697 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ED visits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4705912" y="4802889"/>
              <a:ext cx="1343558" cy="43088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 51-65 years</a:t>
              </a:r>
            </a:p>
            <a:p>
              <a:pPr algn="ctr"/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23,840 ED visits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7489969" y="4802628"/>
              <a:ext cx="1343558" cy="43088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&gt;80 years</a:t>
              </a:r>
            </a:p>
            <a:p>
              <a:pPr algn="ctr"/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14,180 ED visits </a:t>
              </a:r>
            </a:p>
          </p:txBody>
        </p: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21E67B74-76EC-44E0-9401-AF3E28CA5181}"/>
                </a:ext>
              </a:extLst>
            </p:cNvPr>
            <p:cNvCxnSpPr>
              <a:cxnSpLocks/>
            </p:cNvCxnSpPr>
            <p:nvPr/>
          </p:nvCxnSpPr>
          <p:spPr>
            <a:xfrm>
              <a:off x="6116646" y="2220858"/>
              <a:ext cx="2224529" cy="484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FE19D3BE-023F-4B15-A953-DB6821BFFDFE}"/>
                </a:ext>
              </a:extLst>
            </p:cNvPr>
            <p:cNvGrpSpPr/>
            <p:nvPr/>
          </p:nvGrpSpPr>
          <p:grpSpPr>
            <a:xfrm>
              <a:off x="8355651" y="1912530"/>
              <a:ext cx="1852152" cy="535290"/>
              <a:chOff x="3739490" y="260648"/>
              <a:chExt cx="1606691" cy="576064"/>
            </a:xfrm>
          </p:grpSpPr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888F0896-9AF6-4074-950E-67677C632577}"/>
                  </a:ext>
                </a:extLst>
              </p:cNvPr>
              <p:cNvSpPr/>
              <p:nvPr/>
            </p:nvSpPr>
            <p:spPr>
              <a:xfrm>
                <a:off x="3743037" y="260648"/>
                <a:ext cx="1603144" cy="57606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808DD17B-7AB5-4127-B769-75A05F8F1BB5}"/>
                  </a:ext>
                </a:extLst>
              </p:cNvPr>
              <p:cNvSpPr txBox="1"/>
              <p:nvPr/>
            </p:nvSpPr>
            <p:spPr>
              <a:xfrm>
                <a:off x="3739490" y="316880"/>
                <a:ext cx="1603144" cy="46371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GB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3,276 ED visits excluded </a:t>
                </a:r>
              </a:p>
              <a:p>
                <a:pPr algn="ctr"/>
                <a:r>
                  <a:rPr lang="en-GB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&lt; 18 years</a:t>
                </a:r>
              </a:p>
            </p:txBody>
          </p:sp>
        </p:grp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A637E3BC-3736-4C0E-937B-D4A3A8736B2C}"/>
                </a:ext>
              </a:extLst>
            </p:cNvPr>
            <p:cNvGrpSpPr/>
            <p:nvPr/>
          </p:nvGrpSpPr>
          <p:grpSpPr>
            <a:xfrm>
              <a:off x="5154699" y="2428569"/>
              <a:ext cx="1859576" cy="576064"/>
              <a:chOff x="3733049" y="260648"/>
              <a:chExt cx="1613132" cy="576064"/>
            </a:xfrm>
          </p:grpSpPr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35169BE7-B23B-4C67-B8E3-F1FE5670D2EF}"/>
                  </a:ext>
                </a:extLst>
              </p:cNvPr>
              <p:cNvSpPr/>
              <p:nvPr/>
            </p:nvSpPr>
            <p:spPr>
              <a:xfrm>
                <a:off x="3743037" y="260648"/>
                <a:ext cx="1603144" cy="57606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6CD91BEF-26A2-4E6F-B932-57C4AE51EFDF}"/>
                  </a:ext>
                </a:extLst>
              </p:cNvPr>
              <p:cNvSpPr txBox="1"/>
              <p:nvPr/>
            </p:nvSpPr>
            <p:spPr>
              <a:xfrm>
                <a:off x="3733049" y="384815"/>
                <a:ext cx="1603145" cy="430887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GB" sz="1100">
                    <a:latin typeface="Arial" panose="020B0604020202020204" pitchFamily="34" charset="0"/>
                    <a:cs typeface="Arial" panose="020B0604020202020204" pitchFamily="34" charset="0"/>
                  </a:rPr>
                  <a:t>148,828 </a:t>
                </a:r>
                <a:r>
                  <a:rPr lang="en-GB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ED visits </a:t>
                </a:r>
              </a:p>
              <a:p>
                <a:pPr algn="ctr"/>
                <a:r>
                  <a:rPr lang="en-GB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aged ≥18</a:t>
                </a:r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FE2B7C87-6E72-40A0-B012-F1B9B985B62C}"/>
                </a:ext>
              </a:extLst>
            </p:cNvPr>
            <p:cNvGrpSpPr/>
            <p:nvPr/>
          </p:nvGrpSpPr>
          <p:grpSpPr>
            <a:xfrm>
              <a:off x="8249015" y="2746269"/>
              <a:ext cx="1954697" cy="671786"/>
              <a:chOff x="3650534" y="260648"/>
              <a:chExt cx="1695647" cy="576064"/>
            </a:xfrm>
          </p:grpSpPr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4B8D14CD-C898-4227-904C-B6C71611CE1E}"/>
                  </a:ext>
                </a:extLst>
              </p:cNvPr>
              <p:cNvSpPr/>
              <p:nvPr/>
            </p:nvSpPr>
            <p:spPr>
              <a:xfrm>
                <a:off x="3743037" y="260648"/>
                <a:ext cx="1603144" cy="57606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701122C7-09BF-41EE-80A6-EBBBE55D150B}"/>
                  </a:ext>
                </a:extLst>
              </p:cNvPr>
              <p:cNvSpPr txBox="1"/>
              <p:nvPr/>
            </p:nvSpPr>
            <p:spPr>
              <a:xfrm>
                <a:off x="3650534" y="362238"/>
                <a:ext cx="1695647" cy="36949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GB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3,854 ED visits excluded </a:t>
                </a:r>
              </a:p>
              <a:p>
                <a:pPr algn="ctr"/>
                <a:r>
                  <a:rPr lang="en-GB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 </a:t>
                </a:r>
                <a:r>
                  <a:rPr lang="en-GB" sz="1100">
                    <a:latin typeface="Arial" panose="020B0604020202020204" pitchFamily="34" charset="0"/>
                    <a:cs typeface="Arial" panose="020B0604020202020204" pitchFamily="34" charset="0"/>
                  </a:rPr>
                  <a:t>measured biomarkers</a:t>
                </a:r>
                <a:endParaRPr lang="en-GB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DC6E9FF8-AEB4-40C0-BC5E-F42FCFB20794}"/>
                </a:ext>
              </a:extLst>
            </p:cNvPr>
            <p:cNvCxnSpPr>
              <a:cxnSpLocks/>
            </p:cNvCxnSpPr>
            <p:nvPr/>
          </p:nvCxnSpPr>
          <p:spPr>
            <a:xfrm>
              <a:off x="6084487" y="3199537"/>
              <a:ext cx="2256689" cy="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139">
              <a:extLst>
                <a:ext uri="{FF2B5EF4-FFF2-40B4-BE49-F238E27FC236}">
                  <a16:creationId xmlns:a16="http://schemas.microsoft.com/office/drawing/2014/main" id="{D992627C-4CAF-4E79-B6EC-159E969B020F}"/>
                </a:ext>
              </a:extLst>
            </p:cNvPr>
            <p:cNvCxnSpPr>
              <a:cxnSpLocks/>
              <a:stCxn id="51" idx="2"/>
              <a:endCxn id="47" idx="0"/>
            </p:cNvCxnSpPr>
            <p:nvPr/>
          </p:nvCxnSpPr>
          <p:spPr>
            <a:xfrm>
              <a:off x="6078731" y="2983623"/>
              <a:ext cx="5756" cy="53894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Arrow Connector 139">
              <a:extLst>
                <a:ext uri="{FF2B5EF4-FFF2-40B4-BE49-F238E27FC236}">
                  <a16:creationId xmlns:a16="http://schemas.microsoft.com/office/drawing/2014/main" id="{81EED347-6FA2-4860-8D2D-C90BF6E778B8}"/>
                </a:ext>
              </a:extLst>
            </p:cNvPr>
            <p:cNvCxnSpPr>
              <a:cxnSpLocks/>
            </p:cNvCxnSpPr>
            <p:nvPr/>
          </p:nvCxnSpPr>
          <p:spPr>
            <a:xfrm>
              <a:off x="6061222" y="4007731"/>
              <a:ext cx="0" cy="80736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139">
              <a:extLst>
                <a:ext uri="{FF2B5EF4-FFF2-40B4-BE49-F238E27FC236}">
                  <a16:creationId xmlns:a16="http://schemas.microsoft.com/office/drawing/2014/main" id="{96B5C68D-8714-48C7-AE0D-8CCD2B562D54}"/>
                </a:ext>
              </a:extLst>
            </p:cNvPr>
            <p:cNvCxnSpPr>
              <a:cxnSpLocks/>
            </p:cNvCxnSpPr>
            <p:nvPr/>
          </p:nvCxnSpPr>
          <p:spPr>
            <a:xfrm>
              <a:off x="6095368" y="2024723"/>
              <a:ext cx="7168" cy="43175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EE46EF2-E63C-40FD-8381-E1969F8946DC}"/>
                </a:ext>
              </a:extLst>
            </p:cNvPr>
            <p:cNvSpPr txBox="1"/>
            <p:nvPr/>
          </p:nvSpPr>
          <p:spPr>
            <a:xfrm>
              <a:off x="6075691" y="4802889"/>
              <a:ext cx="1343558" cy="43088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66-80 years</a:t>
              </a:r>
            </a:p>
            <a:p>
              <a:pPr algn="ctr"/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30,257 ED visit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62530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5</TotalTime>
  <Words>83</Words>
  <Application>Microsoft Office PowerPoint</Application>
  <PresentationFormat>Widescreen</PresentationFormat>
  <Paragraphs>2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ijzer, R. (COASS)</dc:creator>
  <cp:lastModifiedBy>Bart</cp:lastModifiedBy>
  <cp:revision>42</cp:revision>
  <dcterms:created xsi:type="dcterms:W3CDTF">2020-01-20T10:20:28Z</dcterms:created>
  <dcterms:modified xsi:type="dcterms:W3CDTF">2021-09-02T10:59:15Z</dcterms:modified>
</cp:coreProperties>
</file>